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1"/>
    <p:restoredTop sz="96165"/>
  </p:normalViewPr>
  <p:slideViewPr>
    <p:cSldViewPr snapToGrid="0">
      <p:cViewPr varScale="1">
        <p:scale>
          <a:sx n="122" d="100"/>
          <a:sy n="122" d="100"/>
        </p:scale>
        <p:origin x="30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1DDA30-F132-C999-3406-7D794C5480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4D746A-7A38-E968-7892-D6F1C6826C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818BC-BDB7-B828-4E0A-50AC59D09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E787CB-F297-7FA7-BC5F-1A55D7359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F031AA-7B76-E19A-56F4-5E7C11E3E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391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4F264C-215B-1DD5-B830-E63F9A88F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6E093D-702B-205D-3B8C-D9B655BF2E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AA30CF-9977-3598-4FEE-8991195CC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C39AF-D58B-A207-C20D-CA217F12C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4EAB2C-2156-0B98-8002-F29A90EFC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65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FDC999-9803-C1B6-AF72-77DEA31A76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88A572-5DAA-050F-CAA8-D0B13FB45E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4876C1-33A7-6F8D-5A9D-D24AF1EB9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6987D8-F9D2-CD6D-C465-2280A8D1F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A2E0B-87EE-E235-039E-4F094C972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981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2E22A-F9AF-C638-1F9E-1BBE95B44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501688-152D-427B-89C2-ABC71F7069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923AA6-3139-AEFA-EE1F-9F3B64A95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89DE69-3F3A-0E25-4F8F-A6B8DCC7F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8259A3-A072-807E-7614-5E1D65E19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28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30967-3605-B5B1-DD57-ED317E0CA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22230E-C645-9228-2E12-7622D01C6C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0FFB99-FE7D-7512-5D93-DB829F38A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3EB2CC-90C9-CF2C-8C63-E106B61438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C9FF7E-B18D-D544-C943-8312BE89E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32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C2876-8794-1666-B5BD-9BE849D6A2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F6393E-C9DE-DA26-2361-5BC4674C74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0EF319-5106-6844-F46F-1469CC6D78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027C74-8D16-BA02-059D-C63D6E5CB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44D87E-2865-C4F3-17C6-5573EC845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8D09EB-5222-65A8-36A2-F9AB9B679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094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AF4AAE-09DC-7445-E69D-3DA0BFFBCC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CE8B6D-0072-403A-30BB-361D97730A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BA5445-4DC7-FB6C-4BB8-F2E24BAA7A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14D802-18BC-9C09-C887-3BBF9F0089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8B4533-7A31-39ED-EF4F-E57E9A3559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8C034C-1CD3-74EE-5359-CD7D6D049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4DE318-71A2-00F4-C3A9-1037786DC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729AA8-0199-55C6-A2BC-959587AF4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826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4CC45F-A9A0-5C75-09F6-49DD3704A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7452F7-2625-B640-EA15-7E0279A9A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41DEEC-66B1-F69D-6370-5CF90FF77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C1333B-C8D2-5747-3A68-3FB800D31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90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035F93-A3CD-43F3-1706-BFFBB5379E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95FBCC-5965-E9AA-F9E2-7645FAD9A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647B68-8F96-03BD-8A4A-EE737D17D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722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9021D-11CA-16E7-21D3-C59D4FAEDE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848B2F-4322-8EE7-B7DF-D8EA9A73B3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E0872E-CF19-58DE-79A0-A153C7068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3AA617-A696-040F-98EF-C9BFF8E87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ABC700-DFE5-11F5-B2B7-F8765B3EF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9CCE1D-D246-5ACA-4B89-74C0D751F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770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41E510-ED27-131D-7AEC-4F56C3B47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9EAB2E-BBA4-578D-41B5-EB11CAE1BB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F30BDA-CA67-5667-9DA8-772C0F0193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34C870-49C0-596B-C59D-F102E4E33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73A6B1-4ABE-1A49-AAC2-A7F3C8FD8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4830D2-369D-269A-7E20-9DC24E9B2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960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D46380-C006-EE1D-74DC-7868371E88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8F68C7-13AB-6667-87F5-614350FC7A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061F5E-C98E-7438-065E-F35A4AB8DE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D7664-189C-B74A-83B6-A34FC345A8CC}" type="datetimeFigureOut">
              <a:rPr lang="en-US" smtClean="0"/>
              <a:t>3/3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DEF48-5C0C-CB66-1B9A-85DC167BDA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2B866E-16E9-9AB3-0027-A8FD3EFFA0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BAD79B-D4FF-CC4C-A0D2-AAE96C6288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36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8E8C2AC-5420-E47A-E94F-6A00A60A98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598744"/>
              </p:ext>
            </p:extLst>
          </p:nvPr>
        </p:nvGraphicFramePr>
        <p:xfrm>
          <a:off x="4267200" y="0"/>
          <a:ext cx="7924800" cy="496837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66275">
                  <a:extLst>
                    <a:ext uri="{9D8B030D-6E8A-4147-A177-3AD203B41FA5}">
                      <a16:colId xmlns:a16="http://schemas.microsoft.com/office/drawing/2014/main" val="2327982923"/>
                    </a:ext>
                  </a:extLst>
                </a:gridCol>
                <a:gridCol w="575504">
                  <a:extLst>
                    <a:ext uri="{9D8B030D-6E8A-4147-A177-3AD203B41FA5}">
                      <a16:colId xmlns:a16="http://schemas.microsoft.com/office/drawing/2014/main" val="315499261"/>
                    </a:ext>
                  </a:extLst>
                </a:gridCol>
                <a:gridCol w="1911019">
                  <a:extLst>
                    <a:ext uri="{9D8B030D-6E8A-4147-A177-3AD203B41FA5}">
                      <a16:colId xmlns:a16="http://schemas.microsoft.com/office/drawing/2014/main" val="3383743466"/>
                    </a:ext>
                  </a:extLst>
                </a:gridCol>
                <a:gridCol w="660723">
                  <a:extLst>
                    <a:ext uri="{9D8B030D-6E8A-4147-A177-3AD203B41FA5}">
                      <a16:colId xmlns:a16="http://schemas.microsoft.com/office/drawing/2014/main" val="1489181627"/>
                    </a:ext>
                  </a:extLst>
                </a:gridCol>
                <a:gridCol w="1341779">
                  <a:extLst>
                    <a:ext uri="{9D8B030D-6E8A-4147-A177-3AD203B41FA5}">
                      <a16:colId xmlns:a16="http://schemas.microsoft.com/office/drawing/2014/main" val="4198139214"/>
                    </a:ext>
                  </a:extLst>
                </a:gridCol>
                <a:gridCol w="1398876">
                  <a:extLst>
                    <a:ext uri="{9D8B030D-6E8A-4147-A177-3AD203B41FA5}">
                      <a16:colId xmlns:a16="http://schemas.microsoft.com/office/drawing/2014/main" val="4137405448"/>
                    </a:ext>
                  </a:extLst>
                </a:gridCol>
                <a:gridCol w="1270624">
                  <a:extLst>
                    <a:ext uri="{9D8B030D-6E8A-4147-A177-3AD203B41FA5}">
                      <a16:colId xmlns:a16="http://schemas.microsoft.com/office/drawing/2014/main" val="2079311485"/>
                    </a:ext>
                  </a:extLst>
                </a:gridCol>
              </a:tblGrid>
              <a:tr h="511463">
                <a:tc rowSpan="3" gridSpan="4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  <a:p>
                      <a:pPr algn="ctr"/>
                      <a:endParaRPr lang="en-US" sz="1400" dirty="0"/>
                    </a:p>
                    <a:p>
                      <a:pPr algn="ctr"/>
                      <a:r>
                        <a:rPr lang="en-US" sz="1400" b="0" dirty="0">
                          <a:solidFill>
                            <a:schemeClr val="tx1"/>
                          </a:solidFill>
                        </a:rPr>
                        <a:t>KDIGO: Prognosis of CKD by GFR </a:t>
                      </a:r>
                    </a:p>
                    <a:p>
                      <a:pPr algn="ctr"/>
                      <a:r>
                        <a:rPr lang="en-US" sz="1400" b="0" dirty="0">
                          <a:solidFill>
                            <a:schemeClr val="tx1"/>
                          </a:solidFill>
                        </a:rPr>
                        <a:t>and albuminuria categories </a:t>
                      </a:r>
                    </a:p>
                  </a:txBody>
                  <a:tcPr>
                    <a:noFill/>
                  </a:tcPr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rowSpan="3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</a:rPr>
                        <a:t>Persistent albuminuria categories</a:t>
                      </a:r>
                    </a:p>
                    <a:p>
                      <a:pPr algn="ctr"/>
                      <a:r>
                        <a:rPr lang="en-US" sz="1400" b="0" dirty="0">
                          <a:solidFill>
                            <a:schemeClr val="tx1"/>
                          </a:solidFill>
                        </a:rPr>
                        <a:t>Description and range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82925940"/>
                  </a:ext>
                </a:extLst>
              </a:tr>
              <a:tr h="292265">
                <a:tc gridSpan="4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A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8574881"/>
                  </a:ext>
                </a:extLst>
              </a:tr>
              <a:tr h="730662">
                <a:tc gridSpan="4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Normal to mildly increas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oderately increas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Severely increase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2746154"/>
                  </a:ext>
                </a:extLst>
              </a:tr>
              <a:tr h="730662">
                <a:tc gridSpan="4">
                  <a:txBody>
                    <a:bodyPr/>
                    <a:lstStyle/>
                    <a:p>
                      <a:pPr algn="ctr"/>
                      <a:endParaRPr 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&lt;30mg/g</a:t>
                      </a:r>
                    </a:p>
                    <a:p>
                      <a:pPr algn="ctr"/>
                      <a:r>
                        <a:rPr lang="en-US" sz="1400" dirty="0"/>
                        <a:t>&lt;3mg/mm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0-300mg/g</a:t>
                      </a:r>
                    </a:p>
                    <a:p>
                      <a:pPr algn="ctr"/>
                      <a:r>
                        <a:rPr lang="en-US" sz="1400" dirty="0"/>
                        <a:t>3-30mg/mm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&gt;300mg/g</a:t>
                      </a:r>
                    </a:p>
                    <a:p>
                      <a:pPr algn="ctr"/>
                      <a:r>
                        <a:rPr lang="en-US" sz="1400" dirty="0"/>
                        <a:t>&gt;30mg/mm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5314382"/>
                  </a:ext>
                </a:extLst>
              </a:tr>
              <a:tr h="292265">
                <a:tc rowSpan="6">
                  <a:txBody>
                    <a:bodyPr/>
                    <a:lstStyle/>
                    <a:p>
                      <a:r>
                        <a:rPr lang="en-US" sz="1400" b="1" dirty="0"/>
                        <a:t>GFR categories (mL/min/1.73m</a:t>
                      </a:r>
                      <a:r>
                        <a:rPr lang="en-US" sz="1400" b="1" baseline="30000" dirty="0"/>
                        <a:t>2</a:t>
                      </a:r>
                      <a:r>
                        <a:rPr lang="en-US" sz="1400" b="1" dirty="0"/>
                        <a:t>)</a:t>
                      </a:r>
                    </a:p>
                    <a:p>
                      <a:r>
                        <a:rPr lang="en-US" sz="1400" dirty="0"/>
                        <a:t>Description and range</a:t>
                      </a:r>
                    </a:p>
                  </a:txBody>
                  <a:tcPr vert="vert270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G1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Normal or high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≧90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6926947"/>
                  </a:ext>
                </a:extLst>
              </a:tr>
              <a:tr h="51146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G2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Mildly decreased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60-89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4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6958031"/>
                  </a:ext>
                </a:extLst>
              </a:tr>
              <a:tr h="51146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G3a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Mildly to moderately</a:t>
                      </a:r>
                      <a:r>
                        <a:rPr lang="en-US" sz="1400" dirty="0"/>
                        <a:t> </a:t>
                      </a:r>
                      <a:r>
                        <a:rPr lang="en-US" sz="1200" dirty="0"/>
                        <a:t>decreased</a:t>
                      </a:r>
                      <a:endParaRPr lang="en-US" sz="1400" dirty="0"/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45-59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542569"/>
                  </a:ext>
                </a:extLst>
              </a:tr>
              <a:tr h="539248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G3b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Moderately to severely decreased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30-4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897936"/>
                  </a:ext>
                </a:extLst>
              </a:tr>
              <a:tr h="511463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G4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Severely decreased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15-29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51862777"/>
                  </a:ext>
                </a:extLst>
              </a:tr>
              <a:tr h="292265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G5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Kidney failure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&lt;15 </a:t>
                      </a:r>
                    </a:p>
                  </a:txBody>
                  <a:tcP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7775288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A58B5DB4-49A5-F5EC-F2BC-F94855892442}"/>
              </a:ext>
            </a:extLst>
          </p:cNvPr>
          <p:cNvSpPr txBox="1"/>
          <p:nvPr/>
        </p:nvSpPr>
        <p:spPr>
          <a:xfrm>
            <a:off x="2300862" y="5001376"/>
            <a:ext cx="101085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Green: low risk (if no other markers of kidney disease, no CKD); Yellow: moderately increased risk; Orange: high risk; Red: very high risk. GFR, glomerular filtration rate, CKD=Chronic kidney diseas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73F8BDD-81CC-6AF8-5A21-081F5BC23524}"/>
              </a:ext>
            </a:extLst>
          </p:cNvPr>
          <p:cNvSpPr txBox="1"/>
          <p:nvPr/>
        </p:nvSpPr>
        <p:spPr>
          <a:xfrm>
            <a:off x="191628" y="5896148"/>
            <a:ext cx="12000372" cy="13157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JM" sz="1400" b="1" dirty="0">
                <a:effectLst/>
                <a:ea typeface="Times New Roman" panose="02020603050405020304" pitchFamily="18" charset="0"/>
              </a:rPr>
              <a:t>Supplemental Figure 1: Risk stratification of chronic kidney disease by Glomerular Filtration rate and albuminuria categories using Kidney disease improving global outcomes: Prognosis Chronic kidney disease</a:t>
            </a:r>
            <a:r>
              <a:rPr lang="en-JM" sz="1400" b="1" baseline="30000" dirty="0">
                <a:effectLst/>
                <a:ea typeface="Times New Roman" panose="02020603050405020304" pitchFamily="18" charset="0"/>
              </a:rPr>
              <a:t>1</a:t>
            </a:r>
            <a:r>
              <a:rPr lang="en-JM" sz="1400" b="1" dirty="0">
                <a:effectLst/>
                <a:ea typeface="Times New Roman" panose="02020603050405020304" pitchFamily="18" charset="0"/>
              </a:rPr>
              <a:t>. </a:t>
            </a:r>
            <a:r>
              <a:rPr lang="en-JM" sz="1200" b="1" dirty="0">
                <a:effectLst/>
                <a:ea typeface="Times New Roman" panose="02020603050405020304" pitchFamily="18" charset="0"/>
              </a:rPr>
              <a:t>Figure reproduced with permission </a:t>
            </a:r>
            <a:r>
              <a:rPr lang="en-JM" sz="2000" b="1" dirty="0">
                <a:effectLst/>
                <a:ea typeface="Times New Roman" panose="02020603050405020304" pitchFamily="18" charset="0"/>
              </a:rPr>
              <a:t> </a:t>
            </a:r>
          </a:p>
          <a:p>
            <a:endParaRPr lang="en-JM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JM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. Stevens PE, Ahmed SB, </a:t>
            </a:r>
            <a:r>
              <a:rPr lang="en-JM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rrero</a:t>
            </a:r>
            <a:r>
              <a:rPr lang="en-JM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JJ et al. KDIGO 2024 Clinical Practice Guideline for the Evaluation and Management of Chronic Kidney Disease. Kidney International. 2024;105(4):S117-S314</a:t>
            </a:r>
          </a:p>
          <a:p>
            <a:r>
              <a:rPr lang="en-JM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256567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04</Words>
  <Application>Microsoft Macintosh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i fisher</dc:creator>
  <cp:lastModifiedBy>lori fisher</cp:lastModifiedBy>
  <cp:revision>2</cp:revision>
  <dcterms:created xsi:type="dcterms:W3CDTF">2025-03-27T22:06:13Z</dcterms:created>
  <dcterms:modified xsi:type="dcterms:W3CDTF">2025-03-31T21:25:05Z</dcterms:modified>
</cp:coreProperties>
</file>